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068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Chart%20in%20BCG%20study%20summary%20(Compatibility%20Mode)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Chart%20in%20BCG%20study%20summary%20(Compatibility%20Mode)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15555576141217681"/>
          <c:y val="0.15892428619042448"/>
          <c:w val="0.73856353249961404"/>
          <c:h val="0.57605932674147364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errBars>
            <c:errBarType val="plus"/>
            <c:errValType val="cust"/>
            <c:plus>
              <c:numRef>
                <c:f>'[Chart in BCG study summary (Compatibility Mode)]Sheet1'!$F$58:$F$69</c:f>
                <c:numCache>
                  <c:formatCode>General</c:formatCode>
                  <c:ptCount val="12"/>
                  <c:pt idx="0">
                    <c:v>0.37605070317615003</c:v>
                  </c:pt>
                  <c:pt idx="1">
                    <c:v>0.30518162554062156</c:v>
                  </c:pt>
                  <c:pt idx="2">
                    <c:v>0.36452760610309348</c:v>
                  </c:pt>
                  <c:pt idx="3">
                    <c:v>0.18924901220547427</c:v>
                  </c:pt>
                  <c:pt idx="4">
                    <c:v>1.1092</c:v>
                  </c:pt>
                  <c:pt idx="5">
                    <c:v>1.1313</c:v>
                  </c:pt>
                  <c:pt idx="6">
                    <c:v>0.62039999999999995</c:v>
                  </c:pt>
                  <c:pt idx="7">
                    <c:v>1.0022</c:v>
                  </c:pt>
                  <c:pt idx="8">
                    <c:v>0.17519999999999999</c:v>
                  </c:pt>
                  <c:pt idx="9">
                    <c:v>0.18270000000000047</c:v>
                  </c:pt>
                  <c:pt idx="10">
                    <c:v>0.23840000000000044</c:v>
                  </c:pt>
                  <c:pt idx="11">
                    <c:v>0.1269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[Chart in BCG study summary (Compatibility Mode)]Sheet1'!$B$58:$C$69</c:f>
              <c:multiLvlStrCache>
                <c:ptCount val="12"/>
                <c:lvl>
                  <c:pt idx="0">
                    <c:v>control</c:v>
                  </c:pt>
                  <c:pt idx="1">
                    <c:v>1,25-VD</c:v>
                  </c:pt>
                  <c:pt idx="2">
                    <c:v>BCG</c:v>
                  </c:pt>
                  <c:pt idx="3">
                    <c:v>BCG+1,25VD</c:v>
                  </c:pt>
                  <c:pt idx="4">
                    <c:v>control</c:v>
                  </c:pt>
                  <c:pt idx="5">
                    <c:v>1,25-VD</c:v>
                  </c:pt>
                  <c:pt idx="6">
                    <c:v>BCG</c:v>
                  </c:pt>
                  <c:pt idx="7">
                    <c:v>BCG+1,25VD</c:v>
                  </c:pt>
                  <c:pt idx="8">
                    <c:v>control</c:v>
                  </c:pt>
                  <c:pt idx="9">
                    <c:v>1,25-VD</c:v>
                  </c:pt>
                  <c:pt idx="10">
                    <c:v>BCG</c:v>
                  </c:pt>
                  <c:pt idx="11">
                    <c:v>BCG+1,25VD</c:v>
                  </c:pt>
                </c:lvl>
                <c:lvl>
                  <c:pt idx="0">
                    <c:v>T24</c:v>
                  </c:pt>
                  <c:pt idx="4">
                    <c:v>TCCSUP</c:v>
                  </c:pt>
                  <c:pt idx="8">
                    <c:v>SVHUC</c:v>
                  </c:pt>
                </c:lvl>
              </c:multiLvlStrCache>
            </c:multiLvlStrRef>
          </c:cat>
          <c:val>
            <c:numRef>
              <c:f>'[Chart in BCG study summary (Compatibility Mode)]Sheet1'!$D$58:$D$69</c:f>
              <c:numCache>
                <c:formatCode>General</c:formatCode>
                <c:ptCount val="12"/>
                <c:pt idx="0">
                  <c:v>3.0220732513518542</c:v>
                </c:pt>
                <c:pt idx="1">
                  <c:v>3.3549255175940726</c:v>
                </c:pt>
                <c:pt idx="2">
                  <c:v>4.1705096155283323</c:v>
                </c:pt>
                <c:pt idx="3">
                  <c:v>4.2255927149550008</c:v>
                </c:pt>
                <c:pt idx="4">
                  <c:v>3.2313264480274206</c:v>
                </c:pt>
                <c:pt idx="5">
                  <c:v>3.526434746875009</c:v>
                </c:pt>
                <c:pt idx="6">
                  <c:v>2.9531832228735202</c:v>
                </c:pt>
                <c:pt idx="7">
                  <c:v>3.2412998447624197</c:v>
                </c:pt>
                <c:pt idx="8">
                  <c:v>0.30293825107351857</c:v>
                </c:pt>
                <c:pt idx="9">
                  <c:v>0.34481827379500202</c:v>
                </c:pt>
                <c:pt idx="10">
                  <c:v>0.41224044274074084</c:v>
                </c:pt>
                <c:pt idx="11">
                  <c:v>0.31662440755500154</c:v>
                </c:pt>
              </c:numCache>
            </c:numRef>
          </c:val>
        </c:ser>
        <c:axId val="78289536"/>
        <c:axId val="79290752"/>
      </c:barChart>
      <c:catAx>
        <c:axId val="78289536"/>
        <c:scaling>
          <c:orientation val="minMax"/>
        </c:scaling>
        <c:axPos val="b"/>
        <c:numFmt formatCode="General" sourceLinked="1"/>
        <c:majorTickMark val="cross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新細明體"/>
                <a:ea typeface="新細明體"/>
                <a:cs typeface="新細明體"/>
              </a:defRPr>
            </a:pPr>
            <a:endParaRPr lang="en-US"/>
          </a:p>
        </c:txPr>
        <c:crossAx val="79290752"/>
        <c:crosses val="autoZero"/>
        <c:auto val="1"/>
        <c:lblAlgn val="ctr"/>
        <c:lblOffset val="100"/>
        <c:tickLblSkip val="1"/>
        <c:tickMarkSkip val="1"/>
      </c:catAx>
      <c:valAx>
        <c:axId val="79290752"/>
        <c:scaling>
          <c:orientation val="minMax"/>
        </c:scaling>
        <c:axPos val="l"/>
        <c:numFmt formatCode="General" sourceLinked="1"/>
        <c:majorTickMark val="cross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新細明體"/>
                <a:ea typeface="新細明體"/>
                <a:cs typeface="新細明體"/>
              </a:defRPr>
            </a:pPr>
            <a:endParaRPr lang="en-US"/>
          </a:p>
        </c:txPr>
        <c:crossAx val="782895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新細明體"/>
          <a:ea typeface="新細明體"/>
          <a:cs typeface="新細明體"/>
        </a:defRPr>
      </a:pPr>
      <a:endParaRPr lang="en-US"/>
    </a:p>
  </c:txPr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10677083333333351"/>
          <c:y val="0.1218300007482165"/>
          <c:w val="0.86783854166666652"/>
          <c:h val="0.59856586229647968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errBars>
            <c:errBarType val="plus"/>
            <c:errValType val="cust"/>
            <c:plus>
              <c:numRef>
                <c:f>'[Chart in BCG study summary (Compatibility Mode)]Sheet1'!$F$103:$F$114</c:f>
                <c:numCache>
                  <c:formatCode>General</c:formatCode>
                  <c:ptCount val="12"/>
                  <c:pt idx="0">
                    <c:v>0.98836228175704366</c:v>
                  </c:pt>
                  <c:pt idx="1">
                    <c:v>0.40397648446413331</c:v>
                  </c:pt>
                  <c:pt idx="2">
                    <c:v>0.22230384612057438</c:v>
                  </c:pt>
                  <c:pt idx="3">
                    <c:v>0.37075193863282752</c:v>
                  </c:pt>
                  <c:pt idx="4">
                    <c:v>0.30495409490610198</c:v>
                  </c:pt>
                  <c:pt idx="5">
                    <c:v>0.20747770964612094</c:v>
                  </c:pt>
                  <c:pt idx="6">
                    <c:v>0.66308144296157556</c:v>
                  </c:pt>
                  <c:pt idx="7">
                    <c:v>0.51165613452786929</c:v>
                  </c:pt>
                  <c:pt idx="8">
                    <c:v>1.0484903433031698</c:v>
                  </c:pt>
                  <c:pt idx="9">
                    <c:v>0.28124099985599532</c:v>
                  </c:pt>
                  <c:pt idx="10">
                    <c:v>0.93829046675323291</c:v>
                  </c:pt>
                  <c:pt idx="11">
                    <c:v>0.54995818022827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[Chart in BCG study summary (Compatibility Mode)]Sheet1'!$B$103:$C$114</c:f>
              <c:multiLvlStrCache>
                <c:ptCount val="12"/>
                <c:lvl>
                  <c:pt idx="0">
                    <c:v>control</c:v>
                  </c:pt>
                  <c:pt idx="1">
                    <c:v>1,25VD</c:v>
                  </c:pt>
                  <c:pt idx="2">
                    <c:v>BCG</c:v>
                  </c:pt>
                  <c:pt idx="3">
                    <c:v>BCG+1,25VD</c:v>
                  </c:pt>
                  <c:pt idx="4">
                    <c:v>control</c:v>
                  </c:pt>
                  <c:pt idx="5">
                    <c:v>VD</c:v>
                  </c:pt>
                  <c:pt idx="6">
                    <c:v>BCG</c:v>
                  </c:pt>
                  <c:pt idx="7">
                    <c:v>BCG+1,25VD</c:v>
                  </c:pt>
                  <c:pt idx="8">
                    <c:v>control</c:v>
                  </c:pt>
                  <c:pt idx="9">
                    <c:v>VD</c:v>
                  </c:pt>
                  <c:pt idx="10">
                    <c:v>BCG</c:v>
                  </c:pt>
                  <c:pt idx="11">
                    <c:v>BCG+1,25VD</c:v>
                  </c:pt>
                </c:lvl>
                <c:lvl>
                  <c:pt idx="0">
                    <c:v>T24</c:v>
                  </c:pt>
                  <c:pt idx="4">
                    <c:v>TCCSUP</c:v>
                  </c:pt>
                  <c:pt idx="8">
                    <c:v>SVHUC</c:v>
                  </c:pt>
                </c:lvl>
              </c:multiLvlStrCache>
            </c:multiLvlStrRef>
          </c:cat>
          <c:val>
            <c:numRef>
              <c:f>'[Chart in BCG study summary (Compatibility Mode)]Sheet1'!$D$103:$D$114</c:f>
              <c:numCache>
                <c:formatCode>General</c:formatCode>
                <c:ptCount val="12"/>
                <c:pt idx="0">
                  <c:v>10.377614000000024</c:v>
                </c:pt>
                <c:pt idx="1">
                  <c:v>7.5781919999999943</c:v>
                </c:pt>
                <c:pt idx="2">
                  <c:v>17.885445999999924</c:v>
                </c:pt>
                <c:pt idx="3">
                  <c:v>17.411402000000002</c:v>
                </c:pt>
                <c:pt idx="4">
                  <c:v>13.785606000000024</c:v>
                </c:pt>
                <c:pt idx="5">
                  <c:v>12.843924000000001</c:v>
                </c:pt>
                <c:pt idx="6">
                  <c:v>58.236840000000008</c:v>
                </c:pt>
                <c:pt idx="7">
                  <c:v>51.926930000000013</c:v>
                </c:pt>
                <c:pt idx="8">
                  <c:v>7.5141319999999796</c:v>
                </c:pt>
                <c:pt idx="9">
                  <c:v>6.2649619999999855</c:v>
                </c:pt>
                <c:pt idx="10">
                  <c:v>6.8415019999999949</c:v>
                </c:pt>
                <c:pt idx="11">
                  <c:v>7.0336819999999989</c:v>
                </c:pt>
              </c:numCache>
            </c:numRef>
          </c:val>
        </c:ser>
        <c:axId val="79297920"/>
        <c:axId val="79316096"/>
      </c:barChart>
      <c:catAx>
        <c:axId val="79297920"/>
        <c:scaling>
          <c:orientation val="minMax"/>
        </c:scaling>
        <c:axPos val="b"/>
        <c:numFmt formatCode="General" sourceLinked="1"/>
        <c:majorTickMark val="cross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850" b="0" i="0" u="none" strike="noStrike" baseline="0">
                <a:solidFill>
                  <a:srgbClr val="000000"/>
                </a:solidFill>
                <a:latin typeface="新細明體"/>
                <a:ea typeface="新細明體"/>
                <a:cs typeface="新細明體"/>
              </a:defRPr>
            </a:pPr>
            <a:endParaRPr lang="en-US"/>
          </a:p>
        </c:txPr>
        <c:crossAx val="79316096"/>
        <c:crosses val="autoZero"/>
        <c:auto val="1"/>
        <c:lblAlgn val="ctr"/>
        <c:lblOffset val="100"/>
        <c:tickLblSkip val="1"/>
        <c:tickMarkSkip val="1"/>
      </c:catAx>
      <c:valAx>
        <c:axId val="79316096"/>
        <c:scaling>
          <c:orientation val="minMax"/>
        </c:scaling>
        <c:axPos val="l"/>
        <c:numFmt formatCode="General" sourceLinked="1"/>
        <c:majorTickMark val="cross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50" b="0" i="0" u="none" strike="noStrike" baseline="0">
                <a:solidFill>
                  <a:srgbClr val="000000"/>
                </a:solidFill>
                <a:latin typeface="新細明體"/>
                <a:ea typeface="新細明體"/>
                <a:cs typeface="新細明體"/>
              </a:defRPr>
            </a:pPr>
            <a:endParaRPr lang="en-US"/>
          </a:p>
        </c:txPr>
        <c:crossAx val="792979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850" b="0" i="0" u="none" strike="noStrike" baseline="0">
          <a:solidFill>
            <a:srgbClr val="000000"/>
          </a:solidFill>
          <a:latin typeface="新細明體"/>
          <a:ea typeface="新細明體"/>
          <a:cs typeface="新細明體"/>
        </a:defRPr>
      </a:pPr>
      <a:endParaRPr lang="en-US"/>
    </a:p>
  </c:txPr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7C90EF-DF7B-44E8-B3AB-25541C819487}" type="datetimeFigureOut">
              <a:rPr lang="en-US" smtClean="0"/>
              <a:pPr/>
              <a:t>10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5C252-BFD9-45F5-8482-8B77A133481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/>
        </p:nvGraphicFramePr>
        <p:xfrm>
          <a:off x="0" y="1556792"/>
          <a:ext cx="4857750" cy="36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4267200" y="1700808"/>
          <a:ext cx="4876800" cy="3528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124" name="TextBox 5"/>
          <p:cNvSpPr txBox="1">
            <a:spLocks noChangeArrowheads="1"/>
          </p:cNvSpPr>
          <p:nvPr/>
        </p:nvSpPr>
        <p:spPr bwMode="auto">
          <a:xfrm rot="-5400000">
            <a:off x="3706019" y="3264694"/>
            <a:ext cx="153193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TNF alpha (pg/ml) </a:t>
            </a:r>
          </a:p>
        </p:txBody>
      </p:sp>
      <p:sp>
        <p:nvSpPr>
          <p:cNvPr id="5125" name="TextBox 6"/>
          <p:cNvSpPr txBox="1">
            <a:spLocks noChangeArrowheads="1"/>
          </p:cNvSpPr>
          <p:nvPr/>
        </p:nvSpPr>
        <p:spPr bwMode="auto">
          <a:xfrm rot="-5400000">
            <a:off x="-107949" y="2970212"/>
            <a:ext cx="1008062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/>
              <a:t>Il-6 (ng/ml) </a:t>
            </a:r>
          </a:p>
        </p:txBody>
      </p:sp>
      <p:sp>
        <p:nvSpPr>
          <p:cNvPr id="5126" name="TextBox 7"/>
          <p:cNvSpPr txBox="1">
            <a:spLocks noChangeArrowheads="1"/>
          </p:cNvSpPr>
          <p:nvPr/>
        </p:nvSpPr>
        <p:spPr bwMode="auto">
          <a:xfrm>
            <a:off x="6611938" y="1125538"/>
            <a:ext cx="2532062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/>
              <a:t>Supplement  Figure 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144780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191000" y="152400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預設簡報設計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預設簡報設計">
    <a:majorFont>
      <a:latin typeface="Arial"/>
      <a:ea typeface="新細明體"/>
      <a:cs typeface=""/>
    </a:majorFont>
    <a:minorFont>
      <a:latin typeface="Arial"/>
      <a:ea typeface="新細明體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預設簡報設計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預設簡報設計">
    <a:majorFont>
      <a:latin typeface="Arial"/>
      <a:ea typeface="新細明體"/>
      <a:cs typeface=""/>
    </a:majorFont>
    <a:minorFont>
      <a:latin typeface="Arial"/>
      <a:ea typeface="新細明體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ee</dc:creator>
  <cp:lastModifiedBy>Lee</cp:lastModifiedBy>
  <cp:revision>2</cp:revision>
  <dcterms:created xsi:type="dcterms:W3CDTF">2013-09-23T18:12:16Z</dcterms:created>
  <dcterms:modified xsi:type="dcterms:W3CDTF">2013-10-03T14:27:39Z</dcterms:modified>
</cp:coreProperties>
</file>